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52E42E-6CA8-4999-84FA-F62F902C216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99C5D3-7C39-4D77-ABA8-A8D25FE932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DFCC8C-BF77-49A4-9678-46629A03145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5A1D26-D620-4AE9-AED7-E70716DAE42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AB6737-A95B-4060-A8D7-17548591F0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AF8346-01CC-44AA-91DE-2CAE5B3BED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902FF8-C941-4A36-8910-7C6067C601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AC243E-5F28-498B-9A3F-465E26092C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011DDD-6A76-45BE-9A1B-D488DCF4A1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C71D7E-45E2-4FBC-A5D5-72F97269D4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825EE1-0ABC-417B-B30D-3558D4236D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9C9E1E-5321-4642-8269-13050E5DEF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16346A6-AD3C-4020-A320-C09FEA2183D5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95280" y="981000"/>
          <a:ext cx="5840280" cy="1079640"/>
        </p:xfrm>
        <a:graphic>
          <a:graphicData uri="http://schemas.openxmlformats.org/drawingml/2006/table">
            <a:tbl>
              <a:tblPr/>
              <a:tblGrid>
                <a:gridCol w="1168560"/>
                <a:gridCol w="1166760"/>
                <a:gridCol w="1168200"/>
                <a:gridCol w="1168560"/>
                <a:gridCol w="1168200"/>
              </a:tblGrid>
              <a:tr h="360360">
                <a:tc>
                  <a:txBody>
                    <a:bodyPr lIns="60120" rIns="6012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intak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0120" marR="60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120" rIns="6012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N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0120" marR="60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120" rIns="6012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H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0120" marR="60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120" rIns="6012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BRE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0120" marR="60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120" rIns="6012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P val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0120" marR="60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0360">
                <a:tc>
                  <a:txBody>
                    <a:bodyPr lIns="60120" rIns="60120" tIns="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Food (g/d)</a:t>
                      </a:r>
                      <a:r>
                        <a:rPr b="0" i="1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 2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0120" marR="60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0120" rIns="6012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5.20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±0.44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0120" marR="60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0120" rIns="6012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4.77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±0.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0120" marR="60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0120" rIns="6012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4.04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±0.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0120" marR="60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0120" rIns="6012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76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0120" marR="60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58920">
                <a:tc>
                  <a:txBody>
                    <a:bodyPr lIns="60120" rIns="60120" tIns="0" bIns="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Calorie (kcal/d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0120" marR="60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120" rIns="6012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19.57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±2.84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0120" marR="60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120" rIns="6012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21.10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±1.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0120" marR="60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120" rIns="6012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18.3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±1.4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0120" marR="60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120" rIns="6012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309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60120" marR="60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1"/>
          <p:cNvSpPr/>
          <p:nvPr/>
        </p:nvSpPr>
        <p:spPr>
          <a:xfrm>
            <a:off x="353880" y="620640"/>
            <a:ext cx="6458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able S1. Daily intakes of food and Calorie of C57BL/6J mice fed in different diets for 7 weeks </a:t>
            </a:r>
            <a:r>
              <a:rPr b="1" i="1" lang="en-US" sz="1200" spc="-1" strike="noStrike" baseline="30000">
                <a:solidFill>
                  <a:srgbClr val="000000"/>
                </a:solidFill>
                <a:latin typeface="Times New Roman"/>
                <a:ea typeface="맑은 고딕"/>
              </a:rPr>
              <a:t>1)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3" name="Rectangle 1"/>
          <p:cNvSpPr/>
          <p:nvPr/>
        </p:nvSpPr>
        <p:spPr>
          <a:xfrm>
            <a:off x="324000" y="2136600"/>
            <a:ext cx="59767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 baseline="30000">
                <a:solidFill>
                  <a:srgbClr val="000000"/>
                </a:solidFill>
                <a:latin typeface="Times New Roman"/>
                <a:ea typeface="맑은 고딕"/>
              </a:rPr>
              <a:t>1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Value are expressed as m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ean ± standard error (n=3 for each group). Values with different alphabet within the same row are significantly different at p&lt;0.05 by Dunca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’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 multiple range test. NS; not significant by ANOVA at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&lt;0.05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 baseline="30000">
                <a:solidFill>
                  <a:srgbClr val="000000"/>
                </a:solidFill>
                <a:latin typeface="Times New Roman"/>
                <a:ea typeface="맑은 고딕"/>
              </a:rPr>
              <a:t>2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Daily food intake was determined base on the total weekly intake per cage (2-3 mice/cage)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10T06:44:07Z</dcterms:created>
  <dc:creator>Your User Name</dc:creator>
  <dc:description/>
  <dc:language>en-US</dc:language>
  <cp:lastModifiedBy>Your User Name</cp:lastModifiedBy>
  <dcterms:modified xsi:type="dcterms:W3CDTF">2012-02-15T08:30:19Z</dcterms:modified>
  <cp:revision>31</cp:revision>
  <dc:subject/>
  <dc:title>슬라이드 1</dc:title>
</cp:coreProperties>
</file>